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4994" autoAdjust="0"/>
    <p:restoredTop sz="94660"/>
  </p:normalViewPr>
  <p:slideViewPr>
    <p:cSldViewPr snapToGrid="0">
      <p:cViewPr>
        <p:scale>
          <a:sx n="90" d="100"/>
          <a:sy n="90" d="100"/>
        </p:scale>
        <p:origin x="-1158" y="-60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22B798A5-2727-4AE3-9055-76A253BBB8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="" xmlns:a16="http://schemas.microsoft.com/office/drawing/2014/main" id="{FCAD74A7-9F26-44CB-9AC2-14ED30148B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D7412C5D-72D0-4F34-B636-9A5546B59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6C8D9D6D-F443-401E-AF56-33C5FB446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10B33CAB-B528-4308-8AA6-79089BC34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3178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37F6AE52-2D63-4D10-B803-E23D352CED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="" xmlns:a16="http://schemas.microsoft.com/office/drawing/2014/main" id="{10CD0DA4-6082-489C-809A-F6251FCAC7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8031577F-BAE4-43C5-AA15-DEA9C41FD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1D8EAC89-ECC8-4001-9EA2-F5E901C85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6EBF8670-D0F4-41ED-A990-8BBEED3EB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2272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="" xmlns:a16="http://schemas.microsoft.com/office/drawing/2014/main" id="{7DD24EE8-46F5-49DA-9FEB-8810638B9B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="" xmlns:a16="http://schemas.microsoft.com/office/drawing/2014/main" id="{0A563596-9DC4-43F4-A11E-63B7F6D004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E4C9413E-DE1C-4B84-95FF-39CBE10D2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0B400C2D-9D38-48DA-AE51-30F5F57C3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CD11A5F5-857A-48CF-8295-7B607767D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7195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33625154-CF46-47C8-A26B-ED8AF35A6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37697005-33F7-4D8D-95AD-B0209C8538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90CE0118-935B-4EA8-A341-4D87B1E51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3BBF0155-E3FC-4852-954A-0AE3FBA48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F83FF86D-3967-4242-BA55-748A7D647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9001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9FB57A1D-2DBB-45E4-8C95-80AFAE113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508252BA-57EB-47A3-AD58-C322CC852F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B9683A01-9FA6-4540-98B0-49182DE51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A31E773C-0A57-4559-AFDF-CD965B5658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3620FCC9-7727-4E7E-A23B-7CBC0EFFC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880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4129B69A-9A1D-4E6C-B460-10FE7CF816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674046AB-E283-455E-927A-1AE8C5410E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="" xmlns:a16="http://schemas.microsoft.com/office/drawing/2014/main" id="{041DB784-87E6-43A4-9BD0-9697EC0B6C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1427709F-FC3E-4D11-9871-4C5A0BB35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E9A2579D-5F4E-4C5F-AE6A-D7AF85487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304EAFDF-454B-44A1-B1DA-B9CA619C3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2306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4C76A302-3542-4D7E-949D-D1F653A68A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95C75EFF-A679-447E-829D-4670E6B31A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="" xmlns:a16="http://schemas.microsoft.com/office/drawing/2014/main" id="{FE081D96-B2A9-4034-B5E0-CEB888C77E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="" xmlns:a16="http://schemas.microsoft.com/office/drawing/2014/main" id="{270E6EFF-E220-415B-92F2-CAC02BEFEA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="" xmlns:a16="http://schemas.microsoft.com/office/drawing/2014/main" id="{00E7E3C1-6083-4705-B0A8-3B9567C4AE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="" xmlns:a16="http://schemas.microsoft.com/office/drawing/2014/main" id="{BEA24740-4847-458A-B2FB-5771653F6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="" xmlns:a16="http://schemas.microsoft.com/office/drawing/2014/main" id="{A6BD67DF-FA35-47D0-A9F4-55FAE1A74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="" xmlns:a16="http://schemas.microsoft.com/office/drawing/2014/main" id="{5127007B-3344-4BDB-A608-916D3F624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9724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9D820266-307E-4458-BD8E-C1276E9F82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="" xmlns:a16="http://schemas.microsoft.com/office/drawing/2014/main" id="{8BC139B3-C5AC-484E-8837-FD1458D17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="" xmlns:a16="http://schemas.microsoft.com/office/drawing/2014/main" id="{2EE0EB08-3C9B-4FF0-9747-A66C5C293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="" xmlns:a16="http://schemas.microsoft.com/office/drawing/2014/main" id="{7BEDA5B9-3D9B-452B-BB80-1075DD735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4841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="" xmlns:a16="http://schemas.microsoft.com/office/drawing/2014/main" id="{8310EF70-B289-4CBD-97A1-4EE414F63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="" xmlns:a16="http://schemas.microsoft.com/office/drawing/2014/main" id="{3C6C2D12-A97E-43FC-BBFC-4F9EE731D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="" xmlns:a16="http://schemas.microsoft.com/office/drawing/2014/main" id="{AA069C48-5691-408A-A1FB-BBFD2A26E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6374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1712D60D-458B-4B48-A9AE-8646BA54B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FC43DC40-C81E-4E02-ADFD-C3D0FB830C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="" xmlns:a16="http://schemas.microsoft.com/office/drawing/2014/main" id="{FF01AE67-85B7-437A-99EE-7E852838E0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1236944B-4D5F-41C2-9058-249F0AADC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590C79D1-E232-4618-97E3-6BC806827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6095DD4E-9B4A-48B0-B707-71249E203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4552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13DDC1CF-B835-4C92-947A-EF3F0A4CCE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="" xmlns:a16="http://schemas.microsoft.com/office/drawing/2014/main" id="{54A9553D-7B85-43F9-92F2-048C717F26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="" xmlns:a16="http://schemas.microsoft.com/office/drawing/2014/main" id="{12202FF3-280E-4174-8E1D-FF023CA54F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180D1F7A-F4C9-4FC9-B749-C2127E2FF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FB25EA6C-E8B6-4415-AEF7-ED3E60166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0CD13776-94D2-4EF0-BA90-6F7DD8A7B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4377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="" xmlns:a16="http://schemas.microsoft.com/office/drawing/2014/main" id="{86FE6496-9EAA-46AE-A6A9-D9767EC76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11EEE8DF-8B59-49D8-B141-29B8C435A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9BF758BB-D45D-4246-87FA-25C6D96CF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561886-B222-4A2A-B273-F27FE33C6C0A}" type="datetimeFigureOut">
              <a:rPr lang="de-DE" smtClean="0"/>
              <a:t>25.04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3826AE87-51D0-4614-ADF9-FB44E44528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D0C1C386-275B-45E7-919A-CBEF195992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D5187-92ED-4C94-AE5D-6AD030024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0076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BA2DC91F-94FE-4A4E-9C7F-81F8EF6F874B}"/>
              </a:ext>
            </a:extLst>
          </p:cNvPr>
          <p:cNvSpPr txBox="1"/>
          <p:nvPr/>
        </p:nvSpPr>
        <p:spPr>
          <a:xfrm>
            <a:off x="1062201" y="6514293"/>
            <a:ext cx="62636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ource of </a:t>
            </a:r>
            <a:r>
              <a:rPr lang="de-DE" sz="1100" dirty="0" err="1" smtClean="0"/>
              <a:t>Maps</a:t>
            </a:r>
            <a:r>
              <a:rPr lang="de-DE" sz="1100" dirty="0" smtClean="0"/>
              <a:t>: Kartendaten </a:t>
            </a:r>
            <a:r>
              <a:rPr lang="de-DE" sz="1100" dirty="0"/>
              <a:t>©2018 </a:t>
            </a:r>
            <a:r>
              <a:rPr lang="de-DE" sz="1100" dirty="0" err="1"/>
              <a:t>GeoBasis</a:t>
            </a:r>
            <a:r>
              <a:rPr lang="de-DE" sz="1100" dirty="0"/>
              <a:t>-DE/BKG (©2009),</a:t>
            </a:r>
            <a:r>
              <a:rPr lang="de-DE" sz="1100" dirty="0" err="1"/>
              <a:t>Google,Inst</a:t>
            </a:r>
            <a:r>
              <a:rPr lang="de-DE" sz="1100" dirty="0"/>
              <a:t>. Geogr. </a:t>
            </a:r>
            <a:r>
              <a:rPr lang="de-DE" sz="1100" dirty="0" err="1"/>
              <a:t>Nacional</a:t>
            </a:r>
            <a:endParaRPr lang="de-DE" sz="1100" dirty="0"/>
          </a:p>
        </p:txBody>
      </p:sp>
      <p:pic>
        <p:nvPicPr>
          <p:cNvPr id="8" name="Inhaltsplatzhalter 4">
            <a:extLst>
              <a:ext uri="{FF2B5EF4-FFF2-40B4-BE49-F238E27FC236}">
                <a16:creationId xmlns="" xmlns:a16="http://schemas.microsoft.com/office/drawing/2014/main" id="{DDE9E8E5-E555-40F7-8B95-E432B7F581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2201" y="816160"/>
            <a:ext cx="4570147" cy="5510178"/>
          </a:xfrm>
          <a:prstGeom prst="rect">
            <a:avLst/>
          </a:prstGeom>
        </p:spPr>
      </p:pic>
      <p:pic>
        <p:nvPicPr>
          <p:cNvPr id="13" name="Inhaltsplatzhalter 4">
            <a:extLst>
              <a:ext uri="{FF2B5EF4-FFF2-40B4-BE49-F238E27FC236}">
                <a16:creationId xmlns="" xmlns:a16="http://schemas.microsoft.com/office/drawing/2014/main" id="{AA4EF85E-1DE9-4724-B24B-ABDFBA6CFBBE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4A4A4A"/>
              </a:clrFrom>
              <a:clrTo>
                <a:srgbClr val="4A4A4A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9269" y="820791"/>
            <a:ext cx="4609615" cy="5520639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245624" y="236375"/>
            <a:ext cx="108314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 smtClean="0">
                <a:cs typeface="Arial" panose="020B0604020202020204" pitchFamily="34" charset="0"/>
              </a:rPr>
              <a:t>Supplemental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Document</a:t>
            </a:r>
            <a:r>
              <a:rPr lang="de-DE" sz="1600" b="1" dirty="0" smtClean="0">
                <a:cs typeface="Arial" panose="020B0604020202020204" pitchFamily="34" charset="0"/>
              </a:rPr>
              <a:t> 1: Origin of OXA-48 </a:t>
            </a:r>
            <a:r>
              <a:rPr lang="de-DE" sz="1600" b="1" dirty="0" err="1" smtClean="0">
                <a:cs typeface="Arial" panose="020B0604020202020204" pitchFamily="34" charset="0"/>
              </a:rPr>
              <a:t>producing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Enterobacteriaceae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with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respect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to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veterinary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cs typeface="Arial" panose="020B0604020202020204" pitchFamily="34" charset="0"/>
              </a:rPr>
              <a:t>clinics</a:t>
            </a:r>
            <a:r>
              <a:rPr lang="de-DE" sz="1600" b="1" dirty="0" smtClean="0">
                <a:cs typeface="Arial" panose="020B0604020202020204" pitchFamily="34" charset="0"/>
              </a:rPr>
              <a:t> and </a:t>
            </a:r>
            <a:r>
              <a:rPr lang="de-DE" sz="1600" b="1" dirty="0" err="1" smtClean="0">
                <a:cs typeface="Arial" panose="020B0604020202020204" pitchFamily="34" charset="0"/>
              </a:rPr>
              <a:t>households</a:t>
            </a:r>
            <a:r>
              <a:rPr lang="de-DE" sz="1600" b="1" dirty="0" smtClean="0">
                <a:cs typeface="Arial" panose="020B0604020202020204" pitchFamily="34" charset="0"/>
              </a:rPr>
              <a:t> </a:t>
            </a:r>
            <a:endParaRPr lang="de-DE" sz="1600" b="1" dirty="0">
              <a:cs typeface="Arial" panose="020B0604020202020204" pitchFamily="34" charset="0"/>
            </a:endParaRPr>
          </a:p>
        </p:txBody>
      </p:sp>
      <p:grpSp>
        <p:nvGrpSpPr>
          <p:cNvPr id="5" name="Gruppieren 4"/>
          <p:cNvGrpSpPr/>
          <p:nvPr/>
        </p:nvGrpSpPr>
        <p:grpSpPr>
          <a:xfrm>
            <a:off x="245624" y="815388"/>
            <a:ext cx="2104173" cy="1159197"/>
            <a:chOff x="213725" y="1275907"/>
            <a:chExt cx="2104173" cy="1159197"/>
          </a:xfrm>
        </p:grpSpPr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F9D4BD0C-EBE5-43FF-A7B6-53CCA532F231}"/>
                </a:ext>
              </a:extLst>
            </p:cNvPr>
            <p:cNvSpPr/>
            <p:nvPr/>
          </p:nvSpPr>
          <p:spPr>
            <a:xfrm>
              <a:off x="213725" y="1275907"/>
              <a:ext cx="2104173" cy="1159197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9" name="Grafik 8">
              <a:extLst>
                <a:ext uri="{FF2B5EF4-FFF2-40B4-BE49-F238E27FC236}">
                  <a16:creationId xmlns="" xmlns:a16="http://schemas.microsoft.com/office/drawing/2014/main" id="{13827E27-6673-4A20-AEEF-A3038E2948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5410"/>
            <a:stretch/>
          </p:blipFill>
          <p:spPr>
            <a:xfrm>
              <a:off x="267946" y="1351076"/>
              <a:ext cx="279340" cy="285790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="" xmlns:a16="http://schemas.microsoft.com/office/drawing/2014/main" id="{462BBA15-4CA5-491B-B996-08A4673D53A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537" y="1759232"/>
              <a:ext cx="238158" cy="276264"/>
            </a:xfrm>
            <a:prstGeom prst="rect">
              <a:avLst/>
            </a:prstGeom>
          </p:spPr>
        </p:pic>
        <p:sp>
          <p:nvSpPr>
            <p:cNvPr id="14" name="Textfeld 13">
              <a:extLst>
                <a:ext uri="{FF2B5EF4-FFF2-40B4-BE49-F238E27FC236}">
                  <a16:creationId xmlns="" xmlns:a16="http://schemas.microsoft.com/office/drawing/2014/main" id="{5295E450-B5A9-4E19-AEE5-978B6D47FDFB}"/>
                </a:ext>
              </a:extLst>
            </p:cNvPr>
            <p:cNvSpPr txBox="1"/>
            <p:nvPr/>
          </p:nvSpPr>
          <p:spPr>
            <a:xfrm>
              <a:off x="628803" y="1363376"/>
              <a:ext cx="1476444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300" dirty="0" err="1" smtClean="0"/>
                <a:t>Clinic</a:t>
              </a:r>
              <a:r>
                <a:rPr lang="de-DE" sz="1300" dirty="0" smtClean="0"/>
                <a:t> </a:t>
              </a:r>
              <a:r>
                <a:rPr lang="de-DE" sz="1300" dirty="0" err="1" smtClean="0"/>
                <a:t>number</a:t>
              </a:r>
              <a:endParaRPr lang="de-DE" sz="1300" dirty="0"/>
            </a:p>
          </p:txBody>
        </p:sp>
        <p:sp>
          <p:nvSpPr>
            <p:cNvPr id="16" name="Textfeld 15">
              <a:extLst>
                <a:ext uri="{FF2B5EF4-FFF2-40B4-BE49-F238E27FC236}">
                  <a16:creationId xmlns="" xmlns:a16="http://schemas.microsoft.com/office/drawing/2014/main" id="{5295E450-B5A9-4E19-AEE5-978B6D47FDFB}"/>
                </a:ext>
              </a:extLst>
            </p:cNvPr>
            <p:cNvSpPr txBox="1"/>
            <p:nvPr/>
          </p:nvSpPr>
          <p:spPr>
            <a:xfrm>
              <a:off x="614613" y="1742607"/>
              <a:ext cx="1703285" cy="692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300" dirty="0" smtClean="0"/>
                <a:t>University </a:t>
              </a:r>
              <a:r>
                <a:rPr lang="de-DE" sz="1300" dirty="0" err="1" smtClean="0"/>
                <a:t>Clinic</a:t>
              </a:r>
              <a:r>
                <a:rPr lang="de-DE" sz="1300" dirty="0" smtClean="0"/>
                <a:t> &amp; </a:t>
              </a:r>
            </a:p>
            <a:p>
              <a:r>
                <a:rPr lang="de-DE" sz="1300" dirty="0" smtClean="0"/>
                <a:t>Institute of Veterinary </a:t>
              </a:r>
              <a:r>
                <a:rPr lang="de-DE" sz="1300" dirty="0" err="1" smtClean="0"/>
                <a:t>Pathology</a:t>
              </a:r>
              <a:endParaRPr lang="de-DE" sz="1300" dirty="0"/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6387161" y="819720"/>
            <a:ext cx="2217590" cy="1373666"/>
            <a:chOff x="291694" y="4274290"/>
            <a:chExt cx="2217590" cy="1373666"/>
          </a:xfrm>
        </p:grpSpPr>
        <p:sp>
          <p:nvSpPr>
            <p:cNvPr id="25" name="Rechteck 24">
              <a:extLst>
                <a:ext uri="{FF2B5EF4-FFF2-40B4-BE49-F238E27FC236}">
                  <a16:creationId xmlns="" xmlns:a16="http://schemas.microsoft.com/office/drawing/2014/main" id="{F9D4BD0C-EBE5-43FF-A7B6-53CCA532F231}"/>
                </a:ext>
              </a:extLst>
            </p:cNvPr>
            <p:cNvSpPr/>
            <p:nvPr/>
          </p:nvSpPr>
          <p:spPr>
            <a:xfrm>
              <a:off x="291694" y="4274290"/>
              <a:ext cx="2111267" cy="1373666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29" name="Grafik 28">
              <a:extLst>
                <a:ext uri="{FF2B5EF4-FFF2-40B4-BE49-F238E27FC236}">
                  <a16:creationId xmlns="" xmlns:a16="http://schemas.microsoft.com/office/drawing/2014/main" id="{AB51AE60-C00F-4CA6-B038-91F66F0B52A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clrChange>
                <a:clrFrom>
                  <a:srgbClr val="DFDFDF"/>
                </a:clrFrom>
                <a:clrTo>
                  <a:srgbClr val="DFDFD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20436" y="4347941"/>
              <a:ext cx="428901" cy="439623"/>
            </a:xfrm>
            <a:prstGeom prst="rect">
              <a:avLst/>
            </a:prstGeom>
          </p:spPr>
        </p:pic>
        <p:sp>
          <p:nvSpPr>
            <p:cNvPr id="28" name="Textfeld 27">
              <a:extLst>
                <a:ext uri="{FF2B5EF4-FFF2-40B4-BE49-F238E27FC236}">
                  <a16:creationId xmlns="" xmlns:a16="http://schemas.microsoft.com/office/drawing/2014/main" id="{5295E450-B5A9-4E19-AEE5-978B6D47FDFB}"/>
                </a:ext>
              </a:extLst>
            </p:cNvPr>
            <p:cNvSpPr txBox="1"/>
            <p:nvPr/>
          </p:nvSpPr>
          <p:spPr>
            <a:xfrm>
              <a:off x="596904" y="4358928"/>
              <a:ext cx="1912380" cy="1246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50" dirty="0" err="1" smtClean="0"/>
                <a:t>Households</a:t>
              </a:r>
              <a:r>
                <a:rPr lang="de-DE" sz="1250" dirty="0" smtClean="0"/>
                <a:t> </a:t>
              </a:r>
              <a:r>
                <a:rPr lang="de-DE" sz="1250" dirty="0"/>
                <a:t>of </a:t>
              </a:r>
              <a:r>
                <a:rPr lang="de-DE" sz="1250" dirty="0" err="1"/>
                <a:t>animals</a:t>
              </a:r>
              <a:r>
                <a:rPr lang="de-DE" sz="1250" dirty="0"/>
                <a:t> </a:t>
              </a:r>
              <a:r>
                <a:rPr lang="de-DE" sz="1250" dirty="0" err="1" smtClean="0"/>
                <a:t>carrying</a:t>
              </a:r>
              <a:r>
                <a:rPr lang="de-DE" sz="1250" dirty="0" smtClean="0"/>
                <a:t> OXA-48 positive </a:t>
              </a:r>
              <a:r>
                <a:rPr lang="de-DE" sz="1250" dirty="0" err="1" smtClean="0"/>
                <a:t>bacteria</a:t>
              </a:r>
              <a:r>
                <a:rPr lang="de-DE" sz="1250" dirty="0" smtClean="0"/>
                <a:t> (</a:t>
              </a:r>
              <a:r>
                <a:rPr lang="de-DE" sz="1250" dirty="0" err="1" smtClean="0"/>
                <a:t>households</a:t>
              </a:r>
              <a:r>
                <a:rPr lang="de-DE" sz="1250" dirty="0" smtClean="0"/>
                <a:t> of </a:t>
              </a:r>
              <a:r>
                <a:rPr lang="de-DE" sz="1250" dirty="0" err="1" smtClean="0"/>
                <a:t>further</a:t>
              </a:r>
              <a:r>
                <a:rPr lang="de-DE" sz="1250" dirty="0" smtClean="0"/>
                <a:t> 27 </a:t>
              </a:r>
              <a:r>
                <a:rPr lang="de-DE" sz="1250" dirty="0" err="1" smtClean="0"/>
                <a:t>animals</a:t>
              </a:r>
              <a:r>
                <a:rPr lang="de-DE" sz="1250" dirty="0" smtClean="0"/>
                <a:t> </a:t>
              </a:r>
              <a:r>
                <a:rPr lang="de-DE" sz="1250" dirty="0" err="1" smtClean="0"/>
                <a:t>were</a:t>
              </a:r>
              <a:r>
                <a:rPr lang="de-DE" sz="1250" dirty="0" smtClean="0"/>
                <a:t> </a:t>
              </a:r>
              <a:r>
                <a:rPr lang="de-DE" sz="1250" dirty="0" err="1" smtClean="0"/>
                <a:t>located</a:t>
              </a:r>
              <a:r>
                <a:rPr lang="de-DE" sz="1250" dirty="0" smtClean="0"/>
                <a:t> in Germany, but countries </a:t>
              </a:r>
              <a:r>
                <a:rPr lang="de-DE" sz="1250" dirty="0" err="1" smtClean="0"/>
                <a:t>were</a:t>
              </a:r>
              <a:r>
                <a:rPr lang="de-DE" sz="1250" dirty="0" smtClean="0"/>
                <a:t> </a:t>
              </a:r>
              <a:r>
                <a:rPr lang="de-DE" sz="1250" dirty="0" err="1" smtClean="0"/>
                <a:t>unknown</a:t>
              </a:r>
              <a:r>
                <a:rPr lang="de-DE" sz="1250" dirty="0" smtClean="0"/>
                <a:t>)</a:t>
              </a:r>
              <a:endParaRPr lang="de-DE" sz="1250" dirty="0"/>
            </a:p>
          </p:txBody>
        </p:sp>
      </p:grpSp>
      <p:sp>
        <p:nvSpPr>
          <p:cNvPr id="33" name="Textfeld 32"/>
          <p:cNvSpPr txBox="1"/>
          <p:nvPr/>
        </p:nvSpPr>
        <p:spPr>
          <a:xfrm>
            <a:off x="1062201" y="6007902"/>
            <a:ext cx="3637599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A: Origin </a:t>
            </a:r>
            <a:r>
              <a:rPr lang="de-DE" sz="1400" b="1" dirty="0" err="1" smtClean="0"/>
              <a:t>with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respect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to</a:t>
            </a:r>
            <a:r>
              <a:rPr lang="de-DE" sz="1400" b="1" dirty="0" smtClean="0"/>
              <a:t> Veterinary </a:t>
            </a:r>
            <a:r>
              <a:rPr lang="de-DE" sz="1400" b="1" dirty="0" err="1" smtClean="0"/>
              <a:t>institution</a:t>
            </a:r>
            <a:endParaRPr lang="de-DE" sz="1400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7159269" y="6033653"/>
            <a:ext cx="2825902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A: Origin </a:t>
            </a:r>
            <a:r>
              <a:rPr lang="de-DE" sz="1400" b="1" dirty="0" err="1" smtClean="0"/>
              <a:t>with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respect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to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household</a:t>
            </a:r>
            <a:endParaRPr lang="de-DE" sz="1400" b="1" dirty="0"/>
          </a:p>
        </p:txBody>
      </p:sp>
    </p:spTree>
    <p:extLst>
      <p:ext uri="{BB962C8B-B14F-4D97-AF65-F5344CB8AC3E}">
        <p14:creationId xmlns:p14="http://schemas.microsoft.com/office/powerpoint/2010/main" val="3396085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Benutzerdefiniert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 pu</dc:creator>
  <cp:lastModifiedBy>Christa Ewers</cp:lastModifiedBy>
  <cp:revision>12</cp:revision>
  <dcterms:created xsi:type="dcterms:W3CDTF">2018-04-12T18:42:19Z</dcterms:created>
  <dcterms:modified xsi:type="dcterms:W3CDTF">2018-04-25T12:55:04Z</dcterms:modified>
</cp:coreProperties>
</file>